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4" autoAdjust="0"/>
    <p:restoredTop sz="94660"/>
  </p:normalViewPr>
  <p:slideViewPr>
    <p:cSldViewPr snapToGrid="0">
      <p:cViewPr>
        <p:scale>
          <a:sx n="130" d="100"/>
          <a:sy n="130" d="100"/>
        </p:scale>
        <p:origin x="-23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jj-snoopy3\projets\equipes_recherche\phages\Jeffrey\Manip%20souris\Juin%202016\calculs%20q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jj-snoopy3\projets\equipes_recherche\phages\Jeffrey\Manip%20souris\Juin%202016\Dosage%20lipocalin%20manip%20FP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jj-snoopy3\projets\equipes_recherche\phages\Jeffrey\Manip%20souris\Juin%202016\Score%20activit&#233;%20inflammation%20sour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174537037037203"/>
          <c:y val="4.8802284329844035E-2"/>
          <c:w val="0.62326759259259634"/>
          <c:h val="0.7839377000951806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tio Phages-FP'!$P$19</c:f>
              <c:strCache>
                <c:ptCount val="1"/>
                <c:pt idx="0">
                  <c:v>A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8"/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19:$T$19</c:f>
              <c:numCache>
                <c:formatCode>0.00E+00</c:formatCode>
                <c:ptCount val="4"/>
                <c:pt idx="0">
                  <c:v>1693861693.8616939</c:v>
                </c:pt>
                <c:pt idx="1">
                  <c:v>3397003745.3183517</c:v>
                </c:pt>
                <c:pt idx="2">
                  <c:v>1131062001.2277472</c:v>
                </c:pt>
                <c:pt idx="3">
                  <c:v>2677248677.24867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95D-4075-B82B-CE2B3CE083A8}"/>
            </c:ext>
          </c:extLst>
        </c:ser>
        <c:ser>
          <c:idx val="1"/>
          <c:order val="1"/>
          <c:tx>
            <c:strRef>
              <c:f>'Ratio Phages-FP'!$P$20</c:f>
              <c:strCache>
                <c:ptCount val="1"/>
                <c:pt idx="0">
                  <c:v>A2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  <c:spPr>
              <a:solidFill>
                <a:schemeClr val="accent1"/>
              </a:solidFill>
              <a:ln>
                <a:noFill/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0:$T$20</c:f>
              <c:numCache>
                <c:formatCode>0.00E+00</c:formatCode>
                <c:ptCount val="4"/>
                <c:pt idx="0">
                  <c:v>708651399.49109542</c:v>
                </c:pt>
                <c:pt idx="1">
                  <c:v>791812865.49707592</c:v>
                </c:pt>
                <c:pt idx="2">
                  <c:v>1131372549.0196078</c:v>
                </c:pt>
                <c:pt idx="3">
                  <c:v>1339869281.04575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95D-4075-B82B-CE2B3CE083A8}"/>
            </c:ext>
          </c:extLst>
        </c:ser>
        <c:ser>
          <c:idx val="2"/>
          <c:order val="2"/>
          <c:tx>
            <c:strRef>
              <c:f>'Ratio Phages-FP'!$P$21</c:f>
              <c:strCache>
                <c:ptCount val="1"/>
                <c:pt idx="0">
                  <c:v>A4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  <c:spPr>
              <a:solidFill>
                <a:srgbClr val="4F81BD"/>
              </a:solidFill>
              <a:ln>
                <a:noFill/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1:$T$21</c:f>
              <c:numCache>
                <c:formatCode>0.00E+00</c:formatCode>
                <c:ptCount val="4"/>
                <c:pt idx="0">
                  <c:v>664516129.03225791</c:v>
                </c:pt>
                <c:pt idx="1">
                  <c:v>1110360360.3603599</c:v>
                </c:pt>
                <c:pt idx="2">
                  <c:v>824652777.77777803</c:v>
                </c:pt>
                <c:pt idx="3">
                  <c:v>1390761548.0649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95D-4075-B82B-CE2B3CE083A8}"/>
            </c:ext>
          </c:extLst>
        </c:ser>
        <c:ser>
          <c:idx val="3"/>
          <c:order val="3"/>
          <c:tx>
            <c:strRef>
              <c:f>'Ratio Phages-FP'!$P$22</c:f>
              <c:strCache>
                <c:ptCount val="1"/>
                <c:pt idx="0">
                  <c:v>B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accent2"/>
              </a:solidFill>
              <a:ln>
                <a:noFill/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2:$T$22</c:f>
              <c:numCache>
                <c:formatCode>0.0E+00</c:formatCode>
                <c:ptCount val="4"/>
                <c:pt idx="0">
                  <c:v>415277777.77777773</c:v>
                </c:pt>
                <c:pt idx="1">
                  <c:v>1291559000.8613236</c:v>
                </c:pt>
                <c:pt idx="2">
                  <c:v>2507122507.1225066</c:v>
                </c:pt>
                <c:pt idx="3">
                  <c:v>1767857142.85713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95D-4075-B82B-CE2B3CE083A8}"/>
            </c:ext>
          </c:extLst>
        </c:ser>
        <c:ser>
          <c:idx val="4"/>
          <c:order val="4"/>
          <c:tx>
            <c:strRef>
              <c:f>'Ratio Phages-FP'!$P$23</c:f>
              <c:strCache>
                <c:ptCount val="1"/>
                <c:pt idx="0">
                  <c:v>B2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  <c:spPr>
              <a:solidFill>
                <a:schemeClr val="accent2"/>
              </a:solidFill>
              <a:ln>
                <a:noFill/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3:$T$23</c:f>
              <c:numCache>
                <c:formatCode>0.0E+00</c:formatCode>
                <c:ptCount val="4"/>
                <c:pt idx="0">
                  <c:v>287675606.64112604</c:v>
                </c:pt>
                <c:pt idx="1">
                  <c:v>900820283.37061882</c:v>
                </c:pt>
                <c:pt idx="2">
                  <c:v>383207070.70707065</c:v>
                </c:pt>
                <c:pt idx="3">
                  <c:v>919841269.84126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95D-4075-B82B-CE2B3CE083A8}"/>
            </c:ext>
          </c:extLst>
        </c:ser>
        <c:ser>
          <c:idx val="5"/>
          <c:order val="5"/>
          <c:tx>
            <c:strRef>
              <c:f>'Ratio Phages-FP'!$P$24</c:f>
              <c:strCache>
                <c:ptCount val="1"/>
                <c:pt idx="0">
                  <c:v>B4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  <c:spPr>
              <a:solidFill>
                <a:schemeClr val="accent2"/>
              </a:solidFill>
              <a:ln>
                <a:noFill/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4:$T$24</c:f>
              <c:numCache>
                <c:formatCode>0.0E+00</c:formatCode>
                <c:ptCount val="4"/>
                <c:pt idx="0">
                  <c:v>314077025.23240274</c:v>
                </c:pt>
                <c:pt idx="1">
                  <c:v>544238683.12757099</c:v>
                </c:pt>
                <c:pt idx="2">
                  <c:v>258397932.81653744</c:v>
                </c:pt>
                <c:pt idx="3">
                  <c:v>584343434.343434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95D-4075-B82B-CE2B3CE083A8}"/>
            </c:ext>
          </c:extLst>
        </c:ser>
        <c:ser>
          <c:idx val="8"/>
          <c:order val="6"/>
          <c:tx>
            <c:strRef>
              <c:f>'Ratio Phages-FP'!$P$27</c:f>
              <c:strCache>
                <c:ptCount val="1"/>
                <c:pt idx="0">
                  <c:v>A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accent1">
                  <a:lumMod val="20000"/>
                  <a:lumOff val="80000"/>
                </a:schemeClr>
              </a:solidFill>
              <a:ln w="15875">
                <a:solidFill>
                  <a:schemeClr val="accent1">
                    <a:lumMod val="75000"/>
                  </a:schemeClr>
                </a:solidFill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7:$T$27</c:f>
              <c:numCache>
                <c:formatCode>0.00E+00</c:formatCode>
                <c:ptCount val="4"/>
                <c:pt idx="0">
                  <c:v>2420629.370629353</c:v>
                </c:pt>
                <c:pt idx="1">
                  <c:v>15602921.348314544</c:v>
                </c:pt>
                <c:pt idx="2">
                  <c:v>11108901.16635973</c:v>
                </c:pt>
                <c:pt idx="3">
                  <c:v>10816296.2962961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295D-4075-B82B-CE2B3CE083A8}"/>
            </c:ext>
          </c:extLst>
        </c:ser>
        <c:ser>
          <c:idx val="9"/>
          <c:order val="7"/>
          <c:tx>
            <c:strRef>
              <c:f>'Ratio Phages-FP'!$P$28</c:f>
              <c:strCache>
                <c:ptCount val="1"/>
                <c:pt idx="0">
                  <c:v>A2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  <c:spPr>
              <a:solidFill>
                <a:srgbClr val="4F81BD">
                  <a:lumMod val="20000"/>
                  <a:lumOff val="80000"/>
                </a:srgbClr>
              </a:solidFill>
              <a:ln w="15875">
                <a:solidFill>
                  <a:srgbClr val="4F81BD">
                    <a:lumMod val="75000"/>
                  </a:srgbClr>
                </a:solidFill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8:$T$28</c:f>
              <c:numCache>
                <c:formatCode>0.00E+00</c:formatCode>
                <c:ptCount val="4"/>
                <c:pt idx="0">
                  <c:v>3246628.4987277347</c:v>
                </c:pt>
                <c:pt idx="1">
                  <c:v>2177319.2982455976</c:v>
                </c:pt>
                <c:pt idx="2">
                  <c:v>2430784.3137254897</c:v>
                </c:pt>
                <c:pt idx="3">
                  <c:v>3094909.31372548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295D-4075-B82B-CE2B3CE083A8}"/>
            </c:ext>
          </c:extLst>
        </c:ser>
        <c:ser>
          <c:idx val="10"/>
          <c:order val="8"/>
          <c:tx>
            <c:strRef>
              <c:f>'Ratio Phages-FP'!$P$29</c:f>
              <c:strCache>
                <c:ptCount val="1"/>
                <c:pt idx="0">
                  <c:v>A4</c:v>
                </c:pt>
              </c:strCache>
            </c:strRef>
          </c:tx>
          <c:spPr>
            <a:ln w="15875">
              <a:noFill/>
            </a:ln>
          </c:spPr>
          <c:marker>
            <c:symbol val="triangle"/>
            <c:size val="7"/>
            <c:spPr>
              <a:solidFill>
                <a:srgbClr val="4F81BD">
                  <a:lumMod val="20000"/>
                  <a:lumOff val="80000"/>
                </a:srgbClr>
              </a:solidFill>
              <a:ln w="15875">
                <a:solidFill>
                  <a:schemeClr val="accent1">
                    <a:lumMod val="75000"/>
                  </a:schemeClr>
                </a:solidFill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29:$T$29</c:f>
              <c:numCache>
                <c:formatCode>0.00E+00</c:formatCode>
                <c:ptCount val="4"/>
                <c:pt idx="0">
                  <c:v>3704731.1827956983</c:v>
                </c:pt>
                <c:pt idx="1">
                  <c:v>2044084.0840840838</c:v>
                </c:pt>
                <c:pt idx="2">
                  <c:v>5431886.5740740737</c:v>
                </c:pt>
                <c:pt idx="3">
                  <c:v>5834189.76279650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295D-4075-B82B-CE2B3CE083A8}"/>
            </c:ext>
          </c:extLst>
        </c:ser>
        <c:ser>
          <c:idx val="11"/>
          <c:order val="9"/>
          <c:tx>
            <c:strRef>
              <c:f>'Ratio Phages-FP'!$P$30</c:f>
              <c:strCache>
                <c:ptCount val="1"/>
                <c:pt idx="0">
                  <c:v>B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rgbClr val="4F81BD">
                  <a:lumMod val="20000"/>
                  <a:lumOff val="80000"/>
                </a:srgbClr>
              </a:solidFill>
              <a:ln w="15875">
                <a:solidFill>
                  <a:srgbClr val="C00000"/>
                </a:solidFill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30:$T$30</c:f>
              <c:numCache>
                <c:formatCode>0.0E+00</c:formatCode>
                <c:ptCount val="4"/>
                <c:pt idx="0">
                  <c:v>11253229.166666659</c:v>
                </c:pt>
                <c:pt idx="1">
                  <c:v>3392919.8966408083</c:v>
                </c:pt>
                <c:pt idx="2">
                  <c:v>11295227.920227859</c:v>
                </c:pt>
                <c:pt idx="3">
                  <c:v>20197722.2222222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295D-4075-B82B-CE2B3CE083A8}"/>
            </c:ext>
          </c:extLst>
        </c:ser>
        <c:ser>
          <c:idx val="12"/>
          <c:order val="10"/>
          <c:tx>
            <c:strRef>
              <c:f>'Ratio Phages-FP'!$P$31</c:f>
              <c:strCache>
                <c:ptCount val="1"/>
                <c:pt idx="0">
                  <c:v>B2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  <c:spPr>
              <a:solidFill>
                <a:schemeClr val="accent2">
                  <a:lumMod val="20000"/>
                  <a:lumOff val="80000"/>
                </a:schemeClr>
              </a:solidFill>
              <a:ln w="15875">
                <a:solidFill>
                  <a:srgbClr val="C00000"/>
                </a:solidFill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31:$T$31</c:f>
              <c:numCache>
                <c:formatCode>0.0E+00</c:formatCode>
                <c:ptCount val="4"/>
                <c:pt idx="0">
                  <c:v>6176293.1034482801</c:v>
                </c:pt>
                <c:pt idx="1">
                  <c:v>2229664.4295302005</c:v>
                </c:pt>
                <c:pt idx="2">
                  <c:v>10184469.696969679</c:v>
                </c:pt>
                <c:pt idx="3">
                  <c:v>2977274.99999999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295D-4075-B82B-CE2B3CE083A8}"/>
            </c:ext>
          </c:extLst>
        </c:ser>
        <c:ser>
          <c:idx val="13"/>
          <c:order val="11"/>
          <c:tx>
            <c:strRef>
              <c:f>'Ratio Phages-FP'!$P$32</c:f>
              <c:strCache>
                <c:ptCount val="1"/>
                <c:pt idx="0">
                  <c:v>B4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  <c:spPr>
              <a:ln w="15875">
                <a:solidFill>
                  <a:srgbClr val="C00000"/>
                </a:solidFill>
              </a:ln>
            </c:spPr>
          </c:marker>
          <c:xVal>
            <c:numRef>
              <c:f>'Ratio Phages-FP'!$Q$18:$T$18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2</c:v>
                </c:pt>
              </c:numCache>
            </c:numRef>
          </c:xVal>
          <c:yVal>
            <c:numRef>
              <c:f>'Ratio Phages-FP'!$Q$32:$T$32</c:f>
              <c:numCache>
                <c:formatCode>0.0E+00</c:formatCode>
                <c:ptCount val="4"/>
                <c:pt idx="0">
                  <c:v>2804493.1385568827</c:v>
                </c:pt>
                <c:pt idx="1">
                  <c:v>6406915.637860083</c:v>
                </c:pt>
                <c:pt idx="2">
                  <c:v>1903294.5736434108</c:v>
                </c:pt>
                <c:pt idx="3">
                  <c:v>20457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295D-4075-B82B-CE2B3CE083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941824"/>
        <c:axId val="82964480"/>
      </c:scatterChart>
      <c:valAx>
        <c:axId val="82941824"/>
        <c:scaling>
          <c:orientation val="minMax"/>
          <c:max val="1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days)</a:t>
                </a:r>
              </a:p>
            </c:rich>
          </c:tx>
          <c:layout>
            <c:manualLayout>
              <c:xMode val="edge"/>
              <c:yMode val="edge"/>
              <c:x val="0.44549628226775545"/>
              <c:y val="0.920879120879120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82964480"/>
        <c:crossesAt val="1.0000000000000041E-3"/>
        <c:crossBetween val="midCat"/>
        <c:majorUnit val="4"/>
      </c:valAx>
      <c:valAx>
        <c:axId val="82964480"/>
        <c:scaling>
          <c:logBase val="10"/>
          <c:orientation val="minMax"/>
          <c:min val="100000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P</a:t>
                </a:r>
                <a:r>
                  <a:rPr lang="en-US" baseline="0"/>
                  <a:t> and Mushu (copies/g of feces)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5.770618374012452E-3"/>
              <c:y val="0.11699091459721393"/>
            </c:manualLayout>
          </c:layout>
          <c:overlay val="0"/>
        </c:title>
        <c:numFmt formatCode="0E+0" sourceLinked="0"/>
        <c:majorTickMark val="out"/>
        <c:minorTickMark val="out"/>
        <c:tickLblPos val="nextTo"/>
        <c:spPr>
          <a:ln>
            <a:solidFill>
              <a:schemeClr val="tx1">
                <a:lumMod val="65000"/>
                <a:lumOff val="35000"/>
              </a:schemeClr>
            </a:solidFill>
          </a:ln>
        </c:spPr>
        <c:txPr>
          <a:bodyPr/>
          <a:lstStyle/>
          <a:p>
            <a:pPr>
              <a:defRPr b="1"/>
            </a:pPr>
            <a:endParaRPr lang="fr-FR"/>
          </a:p>
        </c:txPr>
        <c:crossAx val="8294182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9291351886827452"/>
          <c:y val="3.4048628536817532E-2"/>
          <c:w val="8.9774457930600918E-2"/>
          <c:h val="0.82640823743185965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919256656357094"/>
          <c:y val="5.6030183727034118E-2"/>
          <c:w val="0.36545358552911994"/>
          <c:h val="0.7931145357686421"/>
        </c:manualLayout>
      </c:layout>
      <c:scatterChart>
        <c:scatterStyle val="lineMarker"/>
        <c:varyColors val="0"/>
        <c:ser>
          <c:idx val="1"/>
          <c:order val="0"/>
          <c:tx>
            <c:strRef>
              <c:f>[1]Sheet0!$Y$34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square"/>
            <c:size val="6"/>
            <c:spPr>
              <a:solidFill>
                <a:srgbClr val="4F81BD"/>
              </a:solidFill>
              <a:ln w="12700">
                <a:solidFill>
                  <a:schemeClr val="tx2"/>
                </a:solidFill>
              </a:ln>
            </c:spPr>
          </c:marker>
          <c:dPt>
            <c:idx val="1"/>
            <c:marker>
              <c:spPr>
                <a:solidFill>
                  <a:schemeClr val="accent2">
                    <a:lumMod val="75000"/>
                  </a:schemeClr>
                </a:solidFill>
                <a:ln w="12700">
                  <a:solidFill>
                    <a:schemeClr val="accent2">
                      <a:lumMod val="50000"/>
                    </a:schemeClr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52F6-4AA8-BFC3-35218A409630}"/>
              </c:ext>
            </c:extLst>
          </c:dPt>
          <c:xVal>
            <c:strRef>
              <c:f>[1]Sheet0!$Y$35:$Z$35</c:f>
              <c:strCache>
                <c:ptCount val="2"/>
                <c:pt idx="0">
                  <c:v>témoin</c:v>
                </c:pt>
                <c:pt idx="1">
                  <c:v>DSS</c:v>
                </c:pt>
              </c:strCache>
            </c:strRef>
          </c:xVal>
          <c:yVal>
            <c:numRef>
              <c:f>([1]Sheet0!$Z$40,[1]Sheet0!$AG$40)</c:f>
              <c:numCache>
                <c:formatCode>General</c:formatCode>
                <c:ptCount val="2"/>
                <c:pt idx="0">
                  <c:v>6880.9969615678265</c:v>
                </c:pt>
                <c:pt idx="1">
                  <c:v>176646.184649145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2F6-4AA8-BFC3-35218A409630}"/>
            </c:ext>
          </c:extLst>
        </c:ser>
        <c:ser>
          <c:idx val="0"/>
          <c:order val="1"/>
          <c:tx>
            <c:strRef>
              <c:f>[1]Sheet0!$X$35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50000"/>
                  </a:schemeClr>
                </a:solidFill>
              </a:ln>
            </c:spPr>
          </c:marker>
          <c:dPt>
            <c:idx val="0"/>
            <c:marker>
              <c:spPr>
                <a:solidFill>
                  <a:schemeClr val="accent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52F6-4AA8-BFC3-35218A409630}"/>
              </c:ext>
            </c:extLst>
          </c:dPt>
          <c:xVal>
            <c:strRef>
              <c:f>[1]Sheet0!$Y$35:$Z$35</c:f>
              <c:strCache>
                <c:ptCount val="2"/>
                <c:pt idx="0">
                  <c:v>témoin</c:v>
                </c:pt>
                <c:pt idx="1">
                  <c:v>DSS</c:v>
                </c:pt>
              </c:strCache>
            </c:strRef>
          </c:xVal>
          <c:yVal>
            <c:numRef>
              <c:f>([1]Sheet0!$Y$40,[1]Sheet0!$AG$40,[1]Sheet0!$AF$40,[1]Sheet0!$AG$40)</c:f>
              <c:numCache>
                <c:formatCode>General</c:formatCode>
                <c:ptCount val="4"/>
                <c:pt idx="0">
                  <c:v>85.753945430131509</c:v>
                </c:pt>
                <c:pt idx="1">
                  <c:v>176646.18464914509</c:v>
                </c:pt>
                <c:pt idx="2">
                  <c:v>336975.53931432898</c:v>
                </c:pt>
                <c:pt idx="3">
                  <c:v>176646.184649145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2F6-4AA8-BFC3-35218A409630}"/>
            </c:ext>
          </c:extLst>
        </c:ser>
        <c:ser>
          <c:idx val="2"/>
          <c:order val="2"/>
          <c:tx>
            <c:strRef>
              <c:f>[1]Sheet0!$Y$34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  <c:spPr>
              <a:solidFill>
                <a:schemeClr val="accent1"/>
              </a:solidFill>
              <a:ln>
                <a:solidFill>
                  <a:srgbClr val="1F497D"/>
                </a:solidFill>
              </a:ln>
            </c:spPr>
          </c:marker>
          <c:dPt>
            <c:idx val="1"/>
            <c:marker>
              <c:spPr>
                <a:solidFill>
                  <a:schemeClr val="accent2">
                    <a:lumMod val="75000"/>
                  </a:schemeClr>
                </a:solidFill>
                <a:ln>
                  <a:solidFill>
                    <a:schemeClr val="accent2">
                      <a:lumMod val="50000"/>
                    </a:schemeClr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52F6-4AA8-BFC3-35218A409630}"/>
              </c:ext>
            </c:extLst>
          </c:dPt>
          <c:xVal>
            <c:strRef>
              <c:f>[1]Sheet0!$Y$35:$Z$35</c:f>
              <c:strCache>
                <c:ptCount val="2"/>
                <c:pt idx="0">
                  <c:v>témoin</c:v>
                </c:pt>
                <c:pt idx="1">
                  <c:v>DSS</c:v>
                </c:pt>
              </c:strCache>
            </c:strRef>
          </c:xVal>
          <c:yVal>
            <c:numRef>
              <c:f>([1]Sheet0!$AA$40,[1]Sheet0!$AH$40)</c:f>
              <c:numCache>
                <c:formatCode>General</c:formatCode>
                <c:ptCount val="2"/>
                <c:pt idx="0">
                  <c:v>1500.6001525797528</c:v>
                </c:pt>
                <c:pt idx="1">
                  <c:v>260968.655072547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2F6-4AA8-BFC3-35218A409630}"/>
            </c:ext>
          </c:extLst>
        </c:ser>
        <c:ser>
          <c:idx val="3"/>
          <c:order val="3"/>
          <c:tx>
            <c:strRef>
              <c:f>[1]Sheet0!$Z$34</c:f>
              <c:strCache>
                <c:ptCount val="1"/>
              </c:strCache>
            </c:strRef>
          </c:tx>
          <c:spPr>
            <a:ln w="28575">
              <a:noFill/>
            </a:ln>
          </c:spPr>
          <c:dPt>
            <c:idx val="0"/>
            <c:marker>
              <c:symbol val="star"/>
              <c:size val="6"/>
              <c:spPr>
                <a:ln w="15875">
                  <a:solidFill>
                    <a:schemeClr val="accent1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52F6-4AA8-BFC3-35218A409630}"/>
              </c:ext>
            </c:extLst>
          </c:dPt>
          <c:dPt>
            <c:idx val="1"/>
            <c:marker>
              <c:symbol val="triangle"/>
              <c:size val="7"/>
              <c:spPr>
                <a:solidFill>
                  <a:schemeClr val="accent2">
                    <a:lumMod val="75000"/>
                  </a:schemeClr>
                </a:solidFill>
                <a:ln w="15875">
                  <a:solidFill>
                    <a:schemeClr val="accent2">
                      <a:lumMod val="50000"/>
                    </a:schemeClr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52F6-4AA8-BFC3-35218A409630}"/>
              </c:ext>
            </c:extLst>
          </c:dPt>
          <c:xVal>
            <c:strRef>
              <c:f>[1]Sheet0!$Y$35:$Z$35</c:f>
              <c:strCache>
                <c:ptCount val="2"/>
                <c:pt idx="0">
                  <c:v>témoin</c:v>
                </c:pt>
                <c:pt idx="1">
                  <c:v>DSS</c:v>
                </c:pt>
              </c:strCache>
            </c:strRef>
          </c:xVal>
          <c:yVal>
            <c:numRef>
              <c:f>([1]Sheet0!$AB$40,[1]Sheet0!$AJ$48)</c:f>
              <c:numCache>
                <c:formatCode>General</c:formatCode>
                <c:ptCount val="2"/>
                <c:pt idx="0">
                  <c:v>5417.8402578381365</c:v>
                </c:pt>
                <c:pt idx="1">
                  <c:v>1223128.43406593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52F6-4AA8-BFC3-35218A409630}"/>
            </c:ext>
          </c:extLst>
        </c:ser>
        <c:ser>
          <c:idx val="4"/>
          <c:order val="4"/>
          <c:tx>
            <c:strRef>
              <c:f>[1]Sheet0!$Z$34</c:f>
              <c:strCache>
                <c:ptCount val="1"/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  <c:spPr>
              <a:solidFill>
                <a:srgbClr val="4F81BD"/>
              </a:solidFill>
              <a:ln>
                <a:solidFill>
                  <a:schemeClr val="tx2"/>
                </a:solidFill>
              </a:ln>
            </c:spPr>
          </c:marker>
          <c:dPt>
            <c:idx val="1"/>
            <c:marker>
              <c:symbol val="star"/>
              <c:size val="7"/>
              <c:spPr>
                <a:noFill/>
                <a:ln w="15875">
                  <a:solidFill>
                    <a:schemeClr val="accent2">
                      <a:lumMod val="75000"/>
                    </a:schemeClr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52F6-4AA8-BFC3-35218A409630}"/>
              </c:ext>
            </c:extLst>
          </c:dPt>
          <c:xVal>
            <c:strRef>
              <c:f>[1]Sheet0!$Y$35:$Z$35</c:f>
              <c:strCache>
                <c:ptCount val="2"/>
                <c:pt idx="0">
                  <c:v>témoin</c:v>
                </c:pt>
                <c:pt idx="1">
                  <c:v>DSS</c:v>
                </c:pt>
              </c:strCache>
            </c:strRef>
          </c:xVal>
          <c:yVal>
            <c:numRef>
              <c:f>([1]Sheet0!$AC$40,[1]Sheet0!$AJ$40)</c:f>
              <c:numCache>
                <c:formatCode>General</c:formatCode>
                <c:ptCount val="2"/>
                <c:pt idx="0">
                  <c:v>8520.6660868498111</c:v>
                </c:pt>
                <c:pt idx="1">
                  <c:v>506150.153467597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52F6-4AA8-BFC3-35218A4096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015936"/>
        <c:axId val="83025920"/>
      </c:scatterChart>
      <c:valAx>
        <c:axId val="83015936"/>
        <c:scaling>
          <c:orientation val="minMax"/>
          <c:max val="2.5"/>
          <c:min val="0.5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>
                <a:lumMod val="75000"/>
                <a:lumOff val="25000"/>
              </a:schemeClr>
            </a:solidFill>
          </a:ln>
        </c:spPr>
        <c:crossAx val="83025920"/>
        <c:crosses val="autoZero"/>
        <c:crossBetween val="midCat"/>
        <c:majorUnit val="1"/>
        <c:minorUnit val="0.5"/>
      </c:valAx>
      <c:valAx>
        <c:axId val="83025920"/>
        <c:scaling>
          <c:logBase val="10"/>
          <c:orientation val="minMax"/>
          <c:min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err="1"/>
                  <a:t>Lipocalin</a:t>
                </a:r>
                <a:r>
                  <a:rPr lang="en-US" baseline="0" dirty="0"/>
                  <a:t> concentration in feces (pg/g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2.4780898805150914E-2"/>
              <c:y val="5.388432267884323E-2"/>
            </c:manualLayout>
          </c:layout>
          <c:overlay val="0"/>
        </c:title>
        <c:numFmt formatCode="0E+0" sourceLinked="0"/>
        <c:majorTickMark val="out"/>
        <c:minorTickMark val="out"/>
        <c:tickLblPos val="nextTo"/>
        <c:spPr>
          <a:ln>
            <a:solidFill>
              <a:schemeClr val="tx1">
                <a:lumMod val="65000"/>
                <a:lumOff val="35000"/>
              </a:schemeClr>
            </a:solidFill>
          </a:ln>
        </c:spPr>
        <c:crossAx val="8301593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067345679012434"/>
          <c:y val="5.1400554097404488E-2"/>
          <c:w val="0.63705679012345684"/>
          <c:h val="0.8048417906095145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Feuil3!$D$19</c:f>
              <c:strCache>
                <c:ptCount val="1"/>
                <c:pt idx="0">
                  <c:v>A, control</c:v>
                </c:pt>
              </c:strCache>
            </c:strRef>
          </c:tx>
          <c:spPr>
            <a:ln w="19050"/>
          </c:spPr>
          <c:marker>
            <c:symbol val="diamond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Feuil3!$F$20:$F$32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8.268892751682546E-3</c:v>
                  </c:pt>
                  <c:pt idx="2">
                    <c:v>5.7271204981985419E-3</c:v>
                  </c:pt>
                  <c:pt idx="3">
                    <c:v>7.5966294242665938E-3</c:v>
                  </c:pt>
                  <c:pt idx="4">
                    <c:v>4.9861504196727175E-3</c:v>
                  </c:pt>
                  <c:pt idx="5">
                    <c:v>8.3505301151072121E-3</c:v>
                  </c:pt>
                  <c:pt idx="6">
                    <c:v>9.737471520790698E-3</c:v>
                  </c:pt>
                  <c:pt idx="7">
                    <c:v>1.9699479892099227E-2</c:v>
                  </c:pt>
                  <c:pt idx="8">
                    <c:v>1.705912397552159E-2</c:v>
                  </c:pt>
                  <c:pt idx="9">
                    <c:v>1.4390656873352316E-2</c:v>
                  </c:pt>
                  <c:pt idx="10">
                    <c:v>1.4612028483448482E-2</c:v>
                  </c:pt>
                  <c:pt idx="11">
                    <c:v>1.5493485723231649E-2</c:v>
                  </c:pt>
                  <c:pt idx="12">
                    <c:v>1.6529185661181733E-2</c:v>
                  </c:pt>
                </c:numCache>
              </c:numRef>
            </c:plus>
            <c:minus>
              <c:numRef>
                <c:f>Feuil3!$F$20:$F$32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8.268892751682546E-3</c:v>
                  </c:pt>
                  <c:pt idx="2">
                    <c:v>5.7271204981985419E-3</c:v>
                  </c:pt>
                  <c:pt idx="3">
                    <c:v>7.5966294242665938E-3</c:v>
                  </c:pt>
                  <c:pt idx="4">
                    <c:v>4.9861504196727175E-3</c:v>
                  </c:pt>
                  <c:pt idx="5">
                    <c:v>8.3505301151072121E-3</c:v>
                  </c:pt>
                  <c:pt idx="6">
                    <c:v>9.737471520790698E-3</c:v>
                  </c:pt>
                  <c:pt idx="7">
                    <c:v>1.9699479892099227E-2</c:v>
                  </c:pt>
                  <c:pt idx="8">
                    <c:v>1.705912397552159E-2</c:v>
                  </c:pt>
                  <c:pt idx="9">
                    <c:v>1.4390656873352316E-2</c:v>
                  </c:pt>
                  <c:pt idx="10">
                    <c:v>1.4612028483448482E-2</c:v>
                  </c:pt>
                  <c:pt idx="11">
                    <c:v>1.5493485723231649E-2</c:v>
                  </c:pt>
                  <c:pt idx="12">
                    <c:v>1.6529185661181733E-2</c:v>
                  </c:pt>
                </c:numCache>
              </c:numRef>
            </c:minus>
            <c:spPr>
              <a:ln>
                <a:solidFill>
                  <a:schemeClr val="accent1"/>
                </a:solidFill>
              </a:ln>
            </c:spPr>
          </c:errBars>
          <c:xVal>
            <c:numRef>
              <c:f>Feuil3!$B$20:$B$32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Feuil3!$D$20:$D$32</c:f>
              <c:numCache>
                <c:formatCode>0.00%</c:formatCode>
                <c:ptCount val="13"/>
                <c:pt idx="0">
                  <c:v>1</c:v>
                </c:pt>
                <c:pt idx="1">
                  <c:v>0.98996318735314259</c:v>
                </c:pt>
                <c:pt idx="2">
                  <c:v>1.0141227896051006</c:v>
                </c:pt>
                <c:pt idx="3">
                  <c:v>1.0020102827845754</c:v>
                </c:pt>
                <c:pt idx="4">
                  <c:v>1.006889121496553</c:v>
                </c:pt>
                <c:pt idx="5">
                  <c:v>1.0172413688072262</c:v>
                </c:pt>
                <c:pt idx="6">
                  <c:v>1.0047269865651078</c:v>
                </c:pt>
                <c:pt idx="7">
                  <c:v>1.0095689064844786</c:v>
                </c:pt>
                <c:pt idx="8">
                  <c:v>1.0092320576760818</c:v>
                </c:pt>
                <c:pt idx="9">
                  <c:v>1.0189574028392281</c:v>
                </c:pt>
                <c:pt idx="10">
                  <c:v>1.0154486514635044</c:v>
                </c:pt>
                <c:pt idx="11">
                  <c:v>1.0150869253369441</c:v>
                </c:pt>
                <c:pt idx="12">
                  <c:v>1.017709078658083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3BA-4B75-AE6B-BE7BA23A9485}"/>
            </c:ext>
          </c:extLst>
        </c:ser>
        <c:ser>
          <c:idx val="1"/>
          <c:order val="1"/>
          <c:tx>
            <c:strRef>
              <c:f>Feuil3!$G$19</c:f>
              <c:strCache>
                <c:ptCount val="1"/>
                <c:pt idx="0">
                  <c:v>B, DSS</c:v>
                </c:pt>
              </c:strCache>
            </c:strRef>
          </c:tx>
          <c:spPr>
            <a:ln w="19050"/>
          </c:spPr>
          <c:marker>
            <c:symbol val="diamond"/>
            <c:size val="7"/>
            <c:spPr>
              <a:solidFill>
                <a:schemeClr val="accent2"/>
              </a:solidFill>
              <a:ln>
                <a:solidFill>
                  <a:srgbClr val="C0504D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3!$I$20:$I$32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5.5837117457186248E-3</c:v>
                  </c:pt>
                  <c:pt idx="2">
                    <c:v>8.565488425969393E-3</c:v>
                  </c:pt>
                  <c:pt idx="3">
                    <c:v>8.5142859600998017E-3</c:v>
                  </c:pt>
                  <c:pt idx="4">
                    <c:v>1.1905789940675397E-2</c:v>
                  </c:pt>
                  <c:pt idx="5">
                    <c:v>1.0760260315039427E-2</c:v>
                  </c:pt>
                  <c:pt idx="6">
                    <c:v>1.0573480154778131E-2</c:v>
                  </c:pt>
                  <c:pt idx="7">
                    <c:v>1.6896053686670003E-2</c:v>
                  </c:pt>
                  <c:pt idx="8">
                    <c:v>2.1587773756181591E-2</c:v>
                  </c:pt>
                  <c:pt idx="9">
                    <c:v>2.3983071953557093E-2</c:v>
                  </c:pt>
                  <c:pt idx="10">
                    <c:v>1.3330403035838463E-2</c:v>
                  </c:pt>
                  <c:pt idx="11">
                    <c:v>8.4935397250641229E-3</c:v>
                  </c:pt>
                  <c:pt idx="12">
                    <c:v>1.2741044471409052E-2</c:v>
                  </c:pt>
                </c:numCache>
              </c:numRef>
            </c:plus>
            <c:minus>
              <c:numRef>
                <c:f>Feuil3!$I$20:$I$32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5.5837117457186248E-3</c:v>
                  </c:pt>
                  <c:pt idx="2">
                    <c:v>8.565488425969393E-3</c:v>
                  </c:pt>
                  <c:pt idx="3">
                    <c:v>8.5142859600998017E-3</c:v>
                  </c:pt>
                  <c:pt idx="4">
                    <c:v>1.1905789940675397E-2</c:v>
                  </c:pt>
                  <c:pt idx="5">
                    <c:v>1.0760260315039427E-2</c:v>
                  </c:pt>
                  <c:pt idx="6">
                    <c:v>1.0573480154778131E-2</c:v>
                  </c:pt>
                  <c:pt idx="7">
                    <c:v>1.6896053686670003E-2</c:v>
                  </c:pt>
                  <c:pt idx="8">
                    <c:v>2.1587773756181591E-2</c:v>
                  </c:pt>
                  <c:pt idx="9">
                    <c:v>2.3983071953557093E-2</c:v>
                  </c:pt>
                  <c:pt idx="10">
                    <c:v>1.3330403035838463E-2</c:v>
                  </c:pt>
                  <c:pt idx="11">
                    <c:v>8.4935397250641229E-3</c:v>
                  </c:pt>
                  <c:pt idx="12">
                    <c:v>1.2741044471409052E-2</c:v>
                  </c:pt>
                </c:numCache>
              </c:numRef>
            </c:minus>
            <c:spPr>
              <a:ln>
                <a:solidFill>
                  <a:schemeClr val="accent2"/>
                </a:solidFill>
              </a:ln>
            </c:spPr>
          </c:errBars>
          <c:xVal>
            <c:numRef>
              <c:f>Feuil3!$B$20:$B$32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Feuil3!$G$20:$G$32</c:f>
              <c:numCache>
                <c:formatCode>0.00%</c:formatCode>
                <c:ptCount val="13"/>
                <c:pt idx="0">
                  <c:v>1</c:v>
                </c:pt>
                <c:pt idx="1">
                  <c:v>0.97466680367570702</c:v>
                </c:pt>
                <c:pt idx="2">
                  <c:v>0.97043010752688175</c:v>
                </c:pt>
                <c:pt idx="3">
                  <c:v>0.97580645161290325</c:v>
                </c:pt>
                <c:pt idx="4">
                  <c:v>0.97311827956989672</c:v>
                </c:pt>
                <c:pt idx="5">
                  <c:v>0.95788530465950306</c:v>
                </c:pt>
                <c:pt idx="6">
                  <c:v>0.94534050179211448</c:v>
                </c:pt>
                <c:pt idx="7">
                  <c:v>0.93458781362007592</c:v>
                </c:pt>
                <c:pt idx="8">
                  <c:v>0.93996415770609321</c:v>
                </c:pt>
                <c:pt idx="9">
                  <c:v>0.95788530465950328</c:v>
                </c:pt>
                <c:pt idx="10">
                  <c:v>0.98655913978494125</c:v>
                </c:pt>
                <c:pt idx="11">
                  <c:v>0.98476702508960556</c:v>
                </c:pt>
                <c:pt idx="12">
                  <c:v>0.977598566308243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3BA-4B75-AE6B-BE7BA23A94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053952"/>
        <c:axId val="83076608"/>
      </c:scatterChart>
      <c:valAx>
        <c:axId val="83053952"/>
        <c:scaling>
          <c:orientation val="minMax"/>
          <c:max val="1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Day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3076608"/>
        <c:crossesAt val="0"/>
        <c:crossBetween val="midCat"/>
        <c:majorUnit val="4"/>
      </c:valAx>
      <c:valAx>
        <c:axId val="83076608"/>
        <c:scaling>
          <c:orientation val="minMax"/>
          <c:min val="0.80000000000000104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>
                    <a:latin typeface="Arial" pitchFamily="34" charset="0"/>
                    <a:cs typeface="Arial" pitchFamily="34" charset="0"/>
                  </a:rPr>
                  <a:t>relative mouse weigth </a:t>
                </a:r>
              </a:p>
            </c:rich>
          </c:tx>
          <c:layout>
            <c:manualLayout>
              <c:xMode val="edge"/>
              <c:yMode val="edge"/>
              <c:x val="1.2193518518518525E-2"/>
              <c:y val="0.1820376712328767"/>
            </c:manualLayout>
          </c:layout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83053952"/>
        <c:crosses val="autoZero"/>
        <c:crossBetween val="midCat"/>
        <c:minorUnit val="1.0000000000000005E-2"/>
      </c:valAx>
    </c:plotArea>
    <c:legend>
      <c:legendPos val="r"/>
      <c:layout>
        <c:manualLayout>
          <c:xMode val="edge"/>
          <c:yMode val="edge"/>
          <c:x val="0.57580401234568346"/>
          <c:y val="0.54388318112632683"/>
          <c:w val="0.27007561728395196"/>
          <c:h val="0.2993184931506897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914404" y="2130430"/>
            <a:ext cx="103632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828806" y="3886201"/>
            <a:ext cx="8534402" cy="175259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1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6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19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27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5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39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22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5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0453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1841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839204" y="274641"/>
            <a:ext cx="2743201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7" y="274641"/>
            <a:ext cx="8026399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528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9242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63087" y="4406903"/>
            <a:ext cx="10363200" cy="1362075"/>
          </a:xfrm>
        </p:spPr>
        <p:txBody>
          <a:bodyPr anchor="t"/>
          <a:lstStyle>
            <a:lvl1pPr algn="l">
              <a:defRPr sz="3265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963087" y="2906715"/>
            <a:ext cx="10363200" cy="1500187"/>
          </a:xfrm>
        </p:spPr>
        <p:txBody>
          <a:bodyPr anchor="b"/>
          <a:lstStyle>
            <a:lvl1pPr marL="0" indent="0">
              <a:buNone/>
              <a:defRPr sz="1633">
                <a:solidFill>
                  <a:schemeClr val="tx1">
                    <a:tint val="75000"/>
                  </a:schemeClr>
                </a:solidFill>
              </a:defRPr>
            </a:lvl1pPr>
            <a:lvl2pPr marL="373174" indent="0">
              <a:buNone/>
              <a:defRPr sz="1451">
                <a:solidFill>
                  <a:schemeClr val="tx1">
                    <a:tint val="75000"/>
                  </a:schemeClr>
                </a:solidFill>
              </a:defRPr>
            </a:lvl2pPr>
            <a:lvl3pPr marL="746350" indent="0">
              <a:buNone/>
              <a:defRPr sz="1361">
                <a:solidFill>
                  <a:schemeClr val="tx1">
                    <a:tint val="75000"/>
                  </a:schemeClr>
                </a:solidFill>
              </a:defRPr>
            </a:lvl3pPr>
            <a:lvl4pPr marL="1119525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4pPr>
            <a:lvl5pPr marL="1492701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5pPr>
            <a:lvl6pPr marL="1865875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6pPr>
            <a:lvl7pPr marL="2239051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7pPr>
            <a:lvl8pPr marL="2612225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8pPr>
            <a:lvl9pPr marL="2985400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4787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09604" y="1600202"/>
            <a:ext cx="5384802" cy="4525963"/>
          </a:xfrm>
        </p:spPr>
        <p:txBody>
          <a:bodyPr/>
          <a:lstStyle>
            <a:lvl1pPr>
              <a:defRPr sz="2268"/>
            </a:lvl1pPr>
            <a:lvl2pPr>
              <a:defRPr sz="2086"/>
            </a:lvl2pPr>
            <a:lvl3pPr>
              <a:defRPr sz="1633"/>
            </a:lvl3pPr>
            <a:lvl4pPr>
              <a:defRPr sz="1451"/>
            </a:lvl4pPr>
            <a:lvl5pPr>
              <a:defRPr sz="1451"/>
            </a:lvl5pPr>
            <a:lvl6pPr>
              <a:defRPr sz="1451"/>
            </a:lvl6pPr>
            <a:lvl7pPr>
              <a:defRPr sz="1451"/>
            </a:lvl7pPr>
            <a:lvl8pPr>
              <a:defRPr sz="1451"/>
            </a:lvl8pPr>
            <a:lvl9pPr>
              <a:defRPr sz="145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97606" y="1600202"/>
            <a:ext cx="5384802" cy="4525963"/>
          </a:xfrm>
        </p:spPr>
        <p:txBody>
          <a:bodyPr/>
          <a:lstStyle>
            <a:lvl1pPr>
              <a:defRPr sz="2268"/>
            </a:lvl1pPr>
            <a:lvl2pPr>
              <a:defRPr sz="2086"/>
            </a:lvl2pPr>
            <a:lvl3pPr>
              <a:defRPr sz="1633"/>
            </a:lvl3pPr>
            <a:lvl4pPr>
              <a:defRPr sz="1451"/>
            </a:lvl4pPr>
            <a:lvl5pPr>
              <a:defRPr sz="1451"/>
            </a:lvl5pPr>
            <a:lvl6pPr>
              <a:defRPr sz="1451"/>
            </a:lvl6pPr>
            <a:lvl7pPr>
              <a:defRPr sz="1451"/>
            </a:lvl7pPr>
            <a:lvl8pPr>
              <a:defRPr sz="1451"/>
            </a:lvl8pPr>
            <a:lvl9pPr>
              <a:defRPr sz="145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0957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6" y="1535115"/>
            <a:ext cx="5386918" cy="639762"/>
          </a:xfrm>
        </p:spPr>
        <p:txBody>
          <a:bodyPr anchor="b"/>
          <a:lstStyle>
            <a:lvl1pPr marL="0" indent="0">
              <a:buNone/>
              <a:defRPr sz="2086" b="1"/>
            </a:lvl1pPr>
            <a:lvl2pPr marL="373174" indent="0">
              <a:buNone/>
              <a:defRPr sz="1633" b="1"/>
            </a:lvl2pPr>
            <a:lvl3pPr marL="746350" indent="0">
              <a:buNone/>
              <a:defRPr sz="1451" b="1"/>
            </a:lvl3pPr>
            <a:lvl4pPr marL="1119525" indent="0">
              <a:buNone/>
              <a:defRPr sz="1361" b="1"/>
            </a:lvl4pPr>
            <a:lvl5pPr marL="1492701" indent="0">
              <a:buNone/>
              <a:defRPr sz="1361" b="1"/>
            </a:lvl5pPr>
            <a:lvl6pPr marL="1865875" indent="0">
              <a:buNone/>
              <a:defRPr sz="1361" b="1"/>
            </a:lvl6pPr>
            <a:lvl7pPr marL="2239051" indent="0">
              <a:buNone/>
              <a:defRPr sz="1361" b="1"/>
            </a:lvl7pPr>
            <a:lvl8pPr marL="2612225" indent="0">
              <a:buNone/>
              <a:defRPr sz="1361" b="1"/>
            </a:lvl8pPr>
            <a:lvl9pPr marL="2985400" indent="0">
              <a:buNone/>
              <a:defRPr sz="136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09606" y="2174877"/>
            <a:ext cx="5386918" cy="3951289"/>
          </a:xfrm>
        </p:spPr>
        <p:txBody>
          <a:bodyPr/>
          <a:lstStyle>
            <a:lvl1pPr>
              <a:defRPr sz="2086"/>
            </a:lvl1pPr>
            <a:lvl2pPr>
              <a:defRPr sz="1633"/>
            </a:lvl2pPr>
            <a:lvl3pPr>
              <a:defRPr sz="1451"/>
            </a:lvl3pPr>
            <a:lvl4pPr>
              <a:defRPr sz="1361"/>
            </a:lvl4pPr>
            <a:lvl5pPr>
              <a:defRPr sz="1361"/>
            </a:lvl5pPr>
            <a:lvl6pPr>
              <a:defRPr sz="1361"/>
            </a:lvl6pPr>
            <a:lvl7pPr>
              <a:defRPr sz="1361"/>
            </a:lvl7pPr>
            <a:lvl8pPr>
              <a:defRPr sz="1361"/>
            </a:lvl8pPr>
            <a:lvl9pPr>
              <a:defRPr sz="136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93368" y="1535115"/>
            <a:ext cx="5389035" cy="639762"/>
          </a:xfrm>
        </p:spPr>
        <p:txBody>
          <a:bodyPr anchor="b"/>
          <a:lstStyle>
            <a:lvl1pPr marL="0" indent="0">
              <a:buNone/>
              <a:defRPr sz="2086" b="1"/>
            </a:lvl1pPr>
            <a:lvl2pPr marL="373174" indent="0">
              <a:buNone/>
              <a:defRPr sz="1633" b="1"/>
            </a:lvl2pPr>
            <a:lvl3pPr marL="746350" indent="0">
              <a:buNone/>
              <a:defRPr sz="1451" b="1"/>
            </a:lvl3pPr>
            <a:lvl4pPr marL="1119525" indent="0">
              <a:buNone/>
              <a:defRPr sz="1361" b="1"/>
            </a:lvl4pPr>
            <a:lvl5pPr marL="1492701" indent="0">
              <a:buNone/>
              <a:defRPr sz="1361" b="1"/>
            </a:lvl5pPr>
            <a:lvl6pPr marL="1865875" indent="0">
              <a:buNone/>
              <a:defRPr sz="1361" b="1"/>
            </a:lvl6pPr>
            <a:lvl7pPr marL="2239051" indent="0">
              <a:buNone/>
              <a:defRPr sz="1361" b="1"/>
            </a:lvl7pPr>
            <a:lvl8pPr marL="2612225" indent="0">
              <a:buNone/>
              <a:defRPr sz="1361" b="1"/>
            </a:lvl8pPr>
            <a:lvl9pPr marL="2985400" indent="0">
              <a:buNone/>
              <a:defRPr sz="136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93368" y="2174877"/>
            <a:ext cx="5389035" cy="3951289"/>
          </a:xfrm>
        </p:spPr>
        <p:txBody>
          <a:bodyPr/>
          <a:lstStyle>
            <a:lvl1pPr>
              <a:defRPr sz="2086"/>
            </a:lvl1pPr>
            <a:lvl2pPr>
              <a:defRPr sz="1633"/>
            </a:lvl2pPr>
            <a:lvl3pPr>
              <a:defRPr sz="1451"/>
            </a:lvl3pPr>
            <a:lvl4pPr>
              <a:defRPr sz="1361"/>
            </a:lvl4pPr>
            <a:lvl5pPr>
              <a:defRPr sz="1361"/>
            </a:lvl5pPr>
            <a:lvl6pPr>
              <a:defRPr sz="1361"/>
            </a:lvl6pPr>
            <a:lvl7pPr>
              <a:defRPr sz="1361"/>
            </a:lvl7pPr>
            <a:lvl8pPr>
              <a:defRPr sz="1361"/>
            </a:lvl8pPr>
            <a:lvl9pPr>
              <a:defRPr sz="136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7468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9247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8841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09608" y="273053"/>
            <a:ext cx="4011084" cy="1162051"/>
          </a:xfrm>
        </p:spPr>
        <p:txBody>
          <a:bodyPr anchor="b"/>
          <a:lstStyle>
            <a:lvl1pPr algn="l">
              <a:defRPr sz="1633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766736" y="273052"/>
            <a:ext cx="6815667" cy="5853113"/>
          </a:xfrm>
        </p:spPr>
        <p:txBody>
          <a:bodyPr/>
          <a:lstStyle>
            <a:lvl1pPr>
              <a:defRPr sz="2630"/>
            </a:lvl1pPr>
            <a:lvl2pPr>
              <a:defRPr sz="2268"/>
            </a:lvl2pPr>
            <a:lvl3pPr>
              <a:defRPr sz="2086"/>
            </a:lvl3pPr>
            <a:lvl4pPr>
              <a:defRPr sz="1633"/>
            </a:lvl4pPr>
            <a:lvl5pPr>
              <a:defRPr sz="1633"/>
            </a:lvl5pPr>
            <a:lvl6pPr>
              <a:defRPr sz="1633"/>
            </a:lvl6pPr>
            <a:lvl7pPr>
              <a:defRPr sz="1633"/>
            </a:lvl7pPr>
            <a:lvl8pPr>
              <a:defRPr sz="1633"/>
            </a:lvl8pPr>
            <a:lvl9pPr>
              <a:defRPr sz="16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09608" y="1435100"/>
            <a:ext cx="4011084" cy="4691063"/>
          </a:xfrm>
        </p:spPr>
        <p:txBody>
          <a:bodyPr/>
          <a:lstStyle>
            <a:lvl1pPr marL="0" indent="0">
              <a:buNone/>
              <a:defRPr sz="1270"/>
            </a:lvl1pPr>
            <a:lvl2pPr marL="373174" indent="0">
              <a:buNone/>
              <a:defRPr sz="998"/>
            </a:lvl2pPr>
            <a:lvl3pPr marL="746350" indent="0">
              <a:buNone/>
              <a:defRPr sz="816"/>
            </a:lvl3pPr>
            <a:lvl4pPr marL="1119525" indent="0">
              <a:buNone/>
              <a:defRPr sz="726"/>
            </a:lvl4pPr>
            <a:lvl5pPr marL="1492701" indent="0">
              <a:buNone/>
              <a:defRPr sz="726"/>
            </a:lvl5pPr>
            <a:lvl6pPr marL="1865875" indent="0">
              <a:buNone/>
              <a:defRPr sz="726"/>
            </a:lvl6pPr>
            <a:lvl7pPr marL="2239051" indent="0">
              <a:buNone/>
              <a:defRPr sz="726"/>
            </a:lvl7pPr>
            <a:lvl8pPr marL="2612225" indent="0">
              <a:buNone/>
              <a:defRPr sz="726"/>
            </a:lvl8pPr>
            <a:lvl9pPr marL="2985400" indent="0">
              <a:buNone/>
              <a:defRPr sz="726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3152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389724" y="4800602"/>
            <a:ext cx="7315200" cy="566738"/>
          </a:xfrm>
        </p:spPr>
        <p:txBody>
          <a:bodyPr anchor="b"/>
          <a:lstStyle>
            <a:lvl1pPr algn="l">
              <a:defRPr sz="1633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389724" y="612776"/>
            <a:ext cx="7315200" cy="4114800"/>
          </a:xfrm>
        </p:spPr>
        <p:txBody>
          <a:bodyPr/>
          <a:lstStyle>
            <a:lvl1pPr marL="0" indent="0">
              <a:buNone/>
              <a:defRPr sz="2630"/>
            </a:lvl1pPr>
            <a:lvl2pPr marL="373174" indent="0">
              <a:buNone/>
              <a:defRPr sz="2268"/>
            </a:lvl2pPr>
            <a:lvl3pPr marL="746350" indent="0">
              <a:buNone/>
              <a:defRPr sz="2086"/>
            </a:lvl3pPr>
            <a:lvl4pPr marL="1119525" indent="0">
              <a:buNone/>
              <a:defRPr sz="1633"/>
            </a:lvl4pPr>
            <a:lvl5pPr marL="1492701" indent="0">
              <a:buNone/>
              <a:defRPr sz="1633"/>
            </a:lvl5pPr>
            <a:lvl6pPr marL="1865875" indent="0">
              <a:buNone/>
              <a:defRPr sz="1633"/>
            </a:lvl6pPr>
            <a:lvl7pPr marL="2239051" indent="0">
              <a:buNone/>
              <a:defRPr sz="1633"/>
            </a:lvl7pPr>
            <a:lvl8pPr marL="2612225" indent="0">
              <a:buNone/>
              <a:defRPr sz="1633"/>
            </a:lvl8pPr>
            <a:lvl9pPr marL="2985400" indent="0">
              <a:buNone/>
              <a:defRPr sz="1633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389724" y="5367338"/>
            <a:ext cx="7315200" cy="804862"/>
          </a:xfrm>
        </p:spPr>
        <p:txBody>
          <a:bodyPr/>
          <a:lstStyle>
            <a:lvl1pPr marL="0" indent="0">
              <a:buNone/>
              <a:defRPr sz="1270"/>
            </a:lvl1pPr>
            <a:lvl2pPr marL="373174" indent="0">
              <a:buNone/>
              <a:defRPr sz="998"/>
            </a:lvl2pPr>
            <a:lvl3pPr marL="746350" indent="0">
              <a:buNone/>
              <a:defRPr sz="816"/>
            </a:lvl3pPr>
            <a:lvl4pPr marL="1119525" indent="0">
              <a:buNone/>
              <a:defRPr sz="726"/>
            </a:lvl4pPr>
            <a:lvl5pPr marL="1492701" indent="0">
              <a:buNone/>
              <a:defRPr sz="726"/>
            </a:lvl5pPr>
            <a:lvl6pPr marL="1865875" indent="0">
              <a:buNone/>
              <a:defRPr sz="726"/>
            </a:lvl6pPr>
            <a:lvl7pPr marL="2239051" indent="0">
              <a:buNone/>
              <a:defRPr sz="726"/>
            </a:lvl7pPr>
            <a:lvl8pPr marL="2612225" indent="0">
              <a:buNone/>
              <a:defRPr sz="726"/>
            </a:lvl8pPr>
            <a:lvl9pPr marL="2985400" indent="0">
              <a:buNone/>
              <a:defRPr sz="726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12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09602" y="274639"/>
            <a:ext cx="10972801" cy="1143000"/>
          </a:xfrm>
          <a:prstGeom prst="rect">
            <a:avLst/>
          </a:prstGeom>
        </p:spPr>
        <p:txBody>
          <a:bodyPr vert="horz" lIns="82288" tIns="41144" rIns="82288" bIns="41144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2" y="1600202"/>
            <a:ext cx="10972801" cy="4525963"/>
          </a:xfrm>
          <a:prstGeom prst="rect">
            <a:avLst/>
          </a:prstGeom>
        </p:spPr>
        <p:txBody>
          <a:bodyPr vert="horz" lIns="82288" tIns="41144" rIns="82288" bIns="41144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09608" y="6356351"/>
            <a:ext cx="2844801" cy="365126"/>
          </a:xfrm>
          <a:prstGeom prst="rect">
            <a:avLst/>
          </a:prstGeom>
        </p:spPr>
        <p:txBody>
          <a:bodyPr vert="horz" lIns="82288" tIns="41144" rIns="82288" bIns="41144" rtlCol="0" anchor="ctr"/>
          <a:lstStyle>
            <a:lvl1pPr algn="l">
              <a:defRPr sz="9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42C48-815E-4383-916D-C7F8DC0CE170}" type="datetimeFigureOut">
              <a:rPr lang="fr-FR" smtClean="0"/>
              <a:pPr/>
              <a:t>05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165608" y="6356351"/>
            <a:ext cx="3860799" cy="365126"/>
          </a:xfrm>
          <a:prstGeom prst="rect">
            <a:avLst/>
          </a:prstGeom>
        </p:spPr>
        <p:txBody>
          <a:bodyPr vert="horz" lIns="82288" tIns="41144" rIns="82288" bIns="41144" rtlCol="0" anchor="ctr"/>
          <a:lstStyle>
            <a:lvl1pPr algn="ctr">
              <a:defRPr sz="9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737607" y="6356351"/>
            <a:ext cx="2844801" cy="365126"/>
          </a:xfrm>
          <a:prstGeom prst="rect">
            <a:avLst/>
          </a:prstGeom>
        </p:spPr>
        <p:txBody>
          <a:bodyPr vert="horz" lIns="82288" tIns="41144" rIns="82288" bIns="41144" rtlCol="0" anchor="ctr"/>
          <a:lstStyle>
            <a:lvl1pPr algn="r">
              <a:defRPr sz="9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8050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746350" rtl="0" eaLnBrk="1" latinLnBrk="0" hangingPunct="1">
        <a:spcBef>
          <a:spcPct val="0"/>
        </a:spcBef>
        <a:buNone/>
        <a:defRPr sz="37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9882" indent="-279882" algn="l" defTabSz="746350" rtl="0" eaLnBrk="1" latinLnBrk="0" hangingPunct="1">
        <a:spcBef>
          <a:spcPct val="20000"/>
        </a:spcBef>
        <a:buFont typeface="Arial" pitchFamily="34" charset="0"/>
        <a:buChar char="•"/>
        <a:defRPr sz="2630" kern="1200">
          <a:solidFill>
            <a:schemeClr val="tx1"/>
          </a:solidFill>
          <a:latin typeface="+mn-lt"/>
          <a:ea typeface="+mn-ea"/>
          <a:cs typeface="+mn-cs"/>
        </a:defRPr>
      </a:lvl1pPr>
      <a:lvl2pPr marL="606410" indent="-233234" algn="l" defTabSz="746350" rtl="0" eaLnBrk="1" latinLnBrk="0" hangingPunct="1">
        <a:spcBef>
          <a:spcPct val="20000"/>
        </a:spcBef>
        <a:buFont typeface="Arial" pitchFamily="34" charset="0"/>
        <a:buChar char="–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932938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2086" kern="1200">
          <a:solidFill>
            <a:schemeClr val="tx1"/>
          </a:solidFill>
          <a:latin typeface="+mn-lt"/>
          <a:ea typeface="+mn-ea"/>
          <a:cs typeface="+mn-cs"/>
        </a:defRPr>
      </a:lvl3pPr>
      <a:lvl4pPr marL="1306113" indent="-186588" algn="l" defTabSz="746350" rtl="0" eaLnBrk="1" latinLnBrk="0" hangingPunct="1">
        <a:spcBef>
          <a:spcPct val="20000"/>
        </a:spcBef>
        <a:buFont typeface="Arial" pitchFamily="34" charset="0"/>
        <a:buChar char="–"/>
        <a:defRPr sz="1633" kern="1200">
          <a:solidFill>
            <a:schemeClr val="tx1"/>
          </a:solidFill>
          <a:latin typeface="+mn-lt"/>
          <a:ea typeface="+mn-ea"/>
          <a:cs typeface="+mn-cs"/>
        </a:defRPr>
      </a:lvl4pPr>
      <a:lvl5pPr marL="1679287" indent="-186588" algn="l" defTabSz="746350" rtl="0" eaLnBrk="1" latinLnBrk="0" hangingPunct="1">
        <a:spcBef>
          <a:spcPct val="20000"/>
        </a:spcBef>
        <a:buFont typeface="Arial" pitchFamily="34" charset="0"/>
        <a:buChar char="»"/>
        <a:defRPr sz="1633" kern="1200">
          <a:solidFill>
            <a:schemeClr val="tx1"/>
          </a:solidFill>
          <a:latin typeface="+mn-lt"/>
          <a:ea typeface="+mn-ea"/>
          <a:cs typeface="+mn-cs"/>
        </a:defRPr>
      </a:lvl5pPr>
      <a:lvl6pPr marL="2052463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6pPr>
      <a:lvl7pPr marL="2425637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7pPr>
      <a:lvl8pPr marL="2798813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8pPr>
      <a:lvl9pPr marL="3171988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1pPr>
      <a:lvl2pPr marL="373174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2pPr>
      <a:lvl3pPr marL="746350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3pPr>
      <a:lvl4pPr marL="1119525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4pPr>
      <a:lvl5pPr marL="1492701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5pPr>
      <a:lvl6pPr marL="1865875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6pPr>
      <a:lvl7pPr marL="2239051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7pPr>
      <a:lvl8pPr marL="2612225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8pPr>
      <a:lvl9pPr marL="2985400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2"/>
          <p:cNvGraphicFramePr/>
          <p:nvPr/>
        </p:nvGraphicFramePr>
        <p:xfrm>
          <a:off x="2177362" y="1208439"/>
          <a:ext cx="2938652" cy="2383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Graphique 3"/>
          <p:cNvGraphicFramePr/>
          <p:nvPr>
            <p:extLst>
              <p:ext uri="{D42A27DB-BD31-4B8C-83A1-F6EECF244321}">
                <p14:modId xmlns:p14="http://schemas.microsoft.com/office/powerpoint/2010/main" val="2667310365"/>
              </p:ext>
            </p:extLst>
          </p:nvPr>
        </p:nvGraphicFramePr>
        <p:xfrm>
          <a:off x="7595419" y="1208439"/>
          <a:ext cx="2123271" cy="2383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8957798" y="3246545"/>
            <a:ext cx="350216" cy="362917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algn="ctr" defTabSz="746350"/>
            <a:r>
              <a:rPr lang="en-US" sz="907" b="1" dirty="0">
                <a:solidFill>
                  <a:prstClr val="black"/>
                </a:solidFill>
                <a:latin typeface="Calibri"/>
              </a:rPr>
              <a:t>B, </a:t>
            </a:r>
          </a:p>
          <a:p>
            <a:pPr algn="ctr" defTabSz="746350"/>
            <a:r>
              <a:rPr lang="en-US" sz="907" b="1" dirty="0">
                <a:solidFill>
                  <a:prstClr val="black"/>
                </a:solidFill>
                <a:latin typeface="Calibri"/>
              </a:rPr>
              <a:t>DSS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8439945" y="3246545"/>
            <a:ext cx="526547" cy="362917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algn="ctr" defTabSz="746350"/>
            <a:r>
              <a:rPr lang="en-US" sz="907" b="1" dirty="0">
                <a:solidFill>
                  <a:prstClr val="black"/>
                </a:solidFill>
                <a:latin typeface="Calibri"/>
              </a:rPr>
              <a:t>A,</a:t>
            </a:r>
          </a:p>
          <a:p>
            <a:pPr algn="ctr" defTabSz="746350"/>
            <a:r>
              <a:rPr lang="en-US" sz="907" b="1" dirty="0">
                <a:solidFill>
                  <a:prstClr val="black"/>
                </a:solidFill>
                <a:latin typeface="Calibri"/>
              </a:rPr>
              <a:t>Control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2169758" y="881885"/>
            <a:ext cx="266860" cy="27917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270" b="1" dirty="0">
                <a:solidFill>
                  <a:prstClr val="black"/>
                </a:solidFill>
                <a:latin typeface="Calibri"/>
              </a:rPr>
              <a:t>A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5104934" y="881885"/>
            <a:ext cx="258845" cy="27917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270" b="1" dirty="0">
                <a:solidFill>
                  <a:prstClr val="black"/>
                </a:solidFill>
                <a:latin typeface="Calibri"/>
              </a:rPr>
              <a:t>B</a:t>
            </a:r>
          </a:p>
        </p:txBody>
      </p:sp>
      <p:graphicFrame>
        <p:nvGraphicFramePr>
          <p:cNvPr id="9" name="Graphique 8"/>
          <p:cNvGraphicFramePr/>
          <p:nvPr/>
        </p:nvGraphicFramePr>
        <p:xfrm>
          <a:off x="5116341" y="1208439"/>
          <a:ext cx="2938652" cy="2383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7880107" y="881885"/>
            <a:ext cx="254036" cy="27917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270" b="1" dirty="0">
                <a:solidFill>
                  <a:prstClr val="black"/>
                </a:solidFill>
                <a:latin typeface="Calibri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53936206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Grand écran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1_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anne De-Paepe</dc:creator>
  <cp:lastModifiedBy>Jeffrey Cornuault</cp:lastModifiedBy>
  <cp:revision>2</cp:revision>
  <dcterms:created xsi:type="dcterms:W3CDTF">2018-01-04T16:49:10Z</dcterms:created>
  <dcterms:modified xsi:type="dcterms:W3CDTF">2018-01-05T16:12:56Z</dcterms:modified>
</cp:coreProperties>
</file>